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119813" cy="8280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713"/>
  </p:normalViewPr>
  <p:slideViewPr>
    <p:cSldViewPr snapToGrid="0" snapToObjects="1">
      <p:cViewPr varScale="1">
        <p:scale>
          <a:sx n="90" d="100"/>
          <a:sy n="90" d="100"/>
        </p:scale>
        <p:origin x="312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355149"/>
            <a:ext cx="5201841" cy="2882806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349128"/>
            <a:ext cx="4589860" cy="1999179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562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55162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40855"/>
            <a:ext cx="1319585" cy="7017256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40855"/>
            <a:ext cx="3882256" cy="7017256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1751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764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2064352"/>
            <a:ext cx="5278339" cy="3444416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541353"/>
            <a:ext cx="5278339" cy="1811337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73094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204273"/>
            <a:ext cx="2600921" cy="52538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204273"/>
            <a:ext cx="2600921" cy="52538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9194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40856"/>
            <a:ext cx="5278339" cy="1600495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2029849"/>
            <a:ext cx="2588967" cy="99479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3024646"/>
            <a:ext cx="2588967" cy="444879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2029849"/>
            <a:ext cx="2601718" cy="99479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3024646"/>
            <a:ext cx="2601718" cy="444879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9106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49209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14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52027"/>
            <a:ext cx="1973799" cy="1932093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92226"/>
            <a:ext cx="3098155" cy="5884451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84120"/>
            <a:ext cx="1973799" cy="4602140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0123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52027"/>
            <a:ext cx="1973799" cy="1932093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92226"/>
            <a:ext cx="3098155" cy="5884451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84120"/>
            <a:ext cx="1973799" cy="4602140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9131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40856"/>
            <a:ext cx="5278339" cy="1600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204273"/>
            <a:ext cx="5278339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674706"/>
            <a:ext cx="1376958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674706"/>
            <a:ext cx="2065437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674706"/>
            <a:ext cx="1376958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06612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C4672F8-A668-6840-8AE6-30D8924A179D}"/>
              </a:ext>
            </a:extLst>
          </p:cNvPr>
          <p:cNvSpPr txBox="1"/>
          <p:nvPr/>
        </p:nvSpPr>
        <p:spPr>
          <a:xfrm>
            <a:off x="67605" y="1212503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Supplementary Figure </a:t>
            </a:r>
            <a:r>
              <a:rPr lang="en-US" dirty="0"/>
              <a:t>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8933267-5039-0E49-B55A-604DCFFA5A31}"/>
              </a:ext>
            </a:extLst>
          </p:cNvPr>
          <p:cNvSpPr txBox="1"/>
          <p:nvPr/>
        </p:nvSpPr>
        <p:spPr>
          <a:xfrm>
            <a:off x="67605" y="5863073"/>
            <a:ext cx="5950136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dirty="0"/>
              <a:t>Histogram and boxplot of mean percentage of single nucleotide polymorphisms (SNPs) across all samples for each Angiosperm 353 loci produced using HybPhaser (</a:t>
            </a:r>
            <a:r>
              <a:rPr lang="en-US" dirty="0" err="1"/>
              <a:t>Nauheimer</a:t>
            </a:r>
            <a:r>
              <a:rPr lang="en-US" dirty="0"/>
              <a:t> et al., 2021). Samples in red on the histogram and points above the dotted red line in boxplot are loci with SNP diversity 1.5 times higher than the 3</a:t>
            </a:r>
            <a:r>
              <a:rPr lang="en-US" baseline="30000" dirty="0"/>
              <a:t>rd</a:t>
            </a:r>
            <a:r>
              <a:rPr lang="en-US" dirty="0"/>
              <a:t> inter-quartile range for the entire dataset. These loci were removed from phylogenetic analysis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4A1F342-9D2A-1746-8828-5C15DFC87545}"/>
              </a:ext>
            </a:extLst>
          </p:cNvPr>
          <p:cNvSpPr txBox="1"/>
          <p:nvPr/>
        </p:nvSpPr>
        <p:spPr>
          <a:xfrm>
            <a:off x="67605" y="109003"/>
            <a:ext cx="19745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sters et al. </a:t>
            </a:r>
            <a:r>
              <a:rPr lang="en-US"/>
              <a:t>2024</a:t>
            </a:r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7366884-C105-E94E-9B08-02DD768895A8}"/>
              </a:ext>
            </a:extLst>
          </p:cNvPr>
          <p:cNvSpPr txBox="1"/>
          <p:nvPr/>
        </p:nvSpPr>
        <p:spPr>
          <a:xfrm>
            <a:off x="0" y="675520"/>
            <a:ext cx="5556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 Evolutionary origins of the African forage grass </a:t>
            </a:r>
            <a:r>
              <a:rPr lang="en-US" i="1" dirty="0"/>
              <a:t>Urochloa</a:t>
            </a:r>
            <a:r>
              <a:rPr lang="en-US" dirty="0"/>
              <a:t> 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92DCA2C4-B542-404E-BB40-B282EB4F287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829742"/>
            <a:ext cx="6119813" cy="38944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507571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8</TotalTime>
  <Words>89</Words>
  <Application>Microsoft Macintosh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zo Masters</dc:creator>
  <cp:lastModifiedBy>Masters, Lizo E.</cp:lastModifiedBy>
  <cp:revision>13</cp:revision>
  <dcterms:created xsi:type="dcterms:W3CDTF">2023-06-01T15:27:18Z</dcterms:created>
  <dcterms:modified xsi:type="dcterms:W3CDTF">2024-01-25T16:16:44Z</dcterms:modified>
</cp:coreProperties>
</file>